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2"/>
  </p:notesMasterIdLst>
  <p:sldIdLst>
    <p:sldId id="257" r:id="rId2"/>
    <p:sldId id="282" r:id="rId3"/>
    <p:sldId id="258" r:id="rId4"/>
    <p:sldId id="259" r:id="rId5"/>
    <p:sldId id="260" r:id="rId6"/>
    <p:sldId id="261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86" r:id="rId21"/>
    <p:sldId id="276" r:id="rId22"/>
    <p:sldId id="277" r:id="rId23"/>
    <p:sldId id="278" r:id="rId24"/>
    <p:sldId id="279" r:id="rId25"/>
    <p:sldId id="280" r:id="rId26"/>
    <p:sldId id="281" r:id="rId27"/>
    <p:sldId id="287" r:id="rId28"/>
    <p:sldId id="284" r:id="rId29"/>
    <p:sldId id="283" r:id="rId30"/>
    <p:sldId id="285" r:id="rId3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7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cap="sm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dirty="0"/>
              <a:t>Km values for asparagine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cap="sm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3.5190578008980698E-2"/>
          <c:y val="9.3714413847596337E-2"/>
          <c:w val="0.96147095774695857"/>
          <c:h val="0.372402460738296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cap="small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3:$A$33</c:f>
              <c:strCache>
                <c:ptCount val="30"/>
                <c:pt idx="0">
                  <c:v>E.Coli</c:v>
                </c:pt>
                <c:pt idx="1">
                  <c:v>E.chrysanthemi</c:v>
                </c:pt>
                <c:pt idx="2">
                  <c:v>Bacillus altitudinis </c:v>
                </c:pt>
                <c:pt idx="3">
                  <c:v>Bacillus velezensis</c:v>
                </c:pt>
                <c:pt idx="4">
                  <c:v>Bacillus licheniformis</c:v>
                </c:pt>
                <c:pt idx="5">
                  <c:v>Streptomyces brollosae NEAE-115</c:v>
                </c:pt>
                <c:pt idx="6">
                  <c:v>Bacillus halotolerans OHEM18 </c:v>
                </c:pt>
                <c:pt idx="7">
                  <c:v>Streptomyces sp.</c:v>
                </c:pt>
                <c:pt idx="8">
                  <c:v>Lasiodiplodia theobromae</c:v>
                </c:pt>
                <c:pt idx="9">
                  <c:v>A.oryzae CCT 3940</c:v>
                </c:pt>
                <c:pt idx="10">
                  <c:v>A.oryzae LBA 01</c:v>
                </c:pt>
                <c:pt idx="11">
                  <c:v>A. niger LBA 02</c:v>
                </c:pt>
                <c:pt idx="12">
                  <c:v>Aspergillus terreus</c:v>
                </c:pt>
                <c:pt idx="13">
                  <c:v>Sarocladium strictum (yeast)</c:v>
                </c:pt>
                <c:pt idx="14">
                  <c:v>A. oryzae IOC 3999</c:v>
                </c:pt>
                <c:pt idx="15">
                  <c:v>Sarocladium kiliense</c:v>
                </c:pt>
                <c:pt idx="16">
                  <c:v>Bacillus sp.SL-1</c:v>
                </c:pt>
                <c:pt idx="17">
                  <c:v>Cobetia  amphilecti AMI6</c:v>
                </c:pt>
                <c:pt idx="18">
                  <c:v>Melioribacter roseus</c:v>
                </c:pt>
                <c:pt idx="19">
                  <c:v>Thermococcus kodakarensis</c:v>
                </c:pt>
                <c:pt idx="20">
                  <c:v>Pyrococcus furiosus</c:v>
                </c:pt>
                <c:pt idx="21">
                  <c:v>Bacillus subtilis strain R5</c:v>
                </c:pt>
                <c:pt idx="22">
                  <c:v>Pseudomonas fluorescens MTCC 8127</c:v>
                </c:pt>
                <c:pt idx="23">
                  <c:v>Lactobacillus casei subsp. casei ATCC 393</c:v>
                </c:pt>
                <c:pt idx="24">
                  <c:v>Bacillus tequilensis PV9W </c:v>
                </c:pt>
                <c:pt idx="25">
                  <c:v>Halomonas elongata</c:v>
                </c:pt>
                <c:pt idx="26">
                  <c:v>Lactobacillus reuteri DSM 20016</c:v>
                </c:pt>
                <c:pt idx="27">
                  <c:v>Bacillus sonorensis</c:v>
                </c:pt>
                <c:pt idx="28">
                  <c:v>Pyrobaculum calidifontis-Archaea</c:v>
                </c:pt>
                <c:pt idx="29">
                  <c:v>Thermococcus sibiricus</c:v>
                </c:pt>
              </c:strCache>
            </c:strRef>
          </c:cat>
          <c:val>
            <c:numRef>
              <c:f>Sheet1!$B$3:$B$33</c:f>
              <c:numCache>
                <c:formatCode>General</c:formatCode>
                <c:ptCount val="30"/>
                <c:pt idx="0">
                  <c:v>0.02</c:v>
                </c:pt>
                <c:pt idx="1">
                  <c:v>0.05</c:v>
                </c:pt>
                <c:pt idx="2">
                  <c:v>9.09</c:v>
                </c:pt>
                <c:pt idx="3">
                  <c:v>3.5999999999999999E-3</c:v>
                </c:pt>
                <c:pt idx="4">
                  <c:v>4.9995000000000003</c:v>
                </c:pt>
                <c:pt idx="5">
                  <c:v>0.21390000000000001</c:v>
                </c:pt>
                <c:pt idx="6">
                  <c:v>0.47</c:v>
                </c:pt>
                <c:pt idx="7">
                  <c:v>6.5000000000000002E-2</c:v>
                </c:pt>
                <c:pt idx="8">
                  <c:v>9.3700000000000006E-2</c:v>
                </c:pt>
                <c:pt idx="9">
                  <c:v>2.1</c:v>
                </c:pt>
                <c:pt idx="10">
                  <c:v>5.07</c:v>
                </c:pt>
                <c:pt idx="11">
                  <c:v>1.41</c:v>
                </c:pt>
                <c:pt idx="12">
                  <c:v>31.5</c:v>
                </c:pt>
                <c:pt idx="13">
                  <c:v>9.74</c:v>
                </c:pt>
                <c:pt idx="14">
                  <c:v>3.28</c:v>
                </c:pt>
                <c:pt idx="15">
                  <c:v>2.5000000000000001E-2</c:v>
                </c:pt>
                <c:pt idx="16">
                  <c:v>1.0300000000000001E-3</c:v>
                </c:pt>
                <c:pt idx="17">
                  <c:v>2.0499999999999998</c:v>
                </c:pt>
                <c:pt idx="18">
                  <c:v>1.4</c:v>
                </c:pt>
                <c:pt idx="19">
                  <c:v>3.1</c:v>
                </c:pt>
                <c:pt idx="20">
                  <c:v>1.623</c:v>
                </c:pt>
                <c:pt idx="21">
                  <c:v>2.4</c:v>
                </c:pt>
                <c:pt idx="22">
                  <c:v>5</c:v>
                </c:pt>
                <c:pt idx="23">
                  <c:v>1.235E-2</c:v>
                </c:pt>
                <c:pt idx="24">
                  <c:v>0.04</c:v>
                </c:pt>
                <c:pt idx="25">
                  <c:v>5.6</c:v>
                </c:pt>
                <c:pt idx="26">
                  <c:v>0.3332</c:v>
                </c:pt>
                <c:pt idx="27">
                  <c:v>2.004</c:v>
                </c:pt>
                <c:pt idx="28">
                  <c:v>4.5</c:v>
                </c:pt>
                <c:pt idx="29">
                  <c:v>2.8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444"/>
        <c:overlap val="-90"/>
        <c:axId val="384081224"/>
        <c:axId val="384080048"/>
      </c:barChart>
      <c:catAx>
        <c:axId val="3840812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cap="sm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dirty="0" smtClean="0"/>
                  <a:t>bacterial and fungal strains producing l-asparaginases</a:t>
                </a:r>
                <a:endParaRPr lang="en-US" sz="18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cap="sm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cap="sm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4080048"/>
        <c:crosses val="autoZero"/>
        <c:auto val="1"/>
        <c:lblAlgn val="ctr"/>
        <c:lblOffset val="100"/>
        <c:noMultiLvlLbl val="0"/>
      </c:catAx>
      <c:valAx>
        <c:axId val="384080048"/>
        <c:scaling>
          <c:orientation val="minMax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cap="sm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dirty="0"/>
                  <a:t>Km</a:t>
                </a:r>
                <a:r>
                  <a:rPr lang="en-US" sz="1600" baseline="0" dirty="0"/>
                  <a:t> values </a:t>
                </a:r>
                <a:r>
                  <a:rPr lang="en-US" sz="1600" baseline="0" dirty="0" smtClean="0"/>
                  <a:t>(</a:t>
                </a:r>
                <a:r>
                  <a:rPr lang="en-US" sz="1600" baseline="0" dirty="0" err="1" smtClean="0"/>
                  <a:t>milimol</a:t>
                </a:r>
                <a:r>
                  <a:rPr lang="en-US" sz="1600" baseline="0" dirty="0" smtClean="0"/>
                  <a:t>)</a:t>
                </a:r>
                <a:endParaRPr lang="en-US" sz="16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cap="sm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crossAx val="384081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cap="small" baseline="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5078BC-1C42-4DB5-8592-BB6B6B43ADF1}" type="datetimeFigureOut">
              <a:rPr lang="en-US" smtClean="0"/>
              <a:t>7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E64AF0-41EB-49E0-8C38-AA1932A59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216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E64AF0-41EB-49E0-8C38-AA1932A59294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871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FACC-97D6-4B2A-A717-52FC8DD6862F}" type="datetime1">
              <a:rPr lang="en-US" smtClean="0"/>
              <a:t>7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315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D6650-5A91-48A7-B9FE-45B9AB695A3F}" type="datetime1">
              <a:rPr lang="en-US" smtClean="0"/>
              <a:t>7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02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7A30E-282A-4F36-B911-1B980272AA8C}" type="datetime1">
              <a:rPr lang="en-US" smtClean="0"/>
              <a:t>7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95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BC1C6-C301-4A14-8530-AF1832EE2033}" type="datetime1">
              <a:rPr lang="en-US" smtClean="0"/>
              <a:t>7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753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8B06C-9415-4714-8E18-253E600DDA7F}" type="datetime1">
              <a:rPr lang="en-US" smtClean="0"/>
              <a:t>7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704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04F3E-699A-4C22-85F8-F5CDF66F7900}" type="datetime1">
              <a:rPr lang="en-US" smtClean="0"/>
              <a:t>7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653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25B93-4324-4FE6-874D-8DB332C0FDD5}" type="datetime1">
              <a:rPr lang="en-US" smtClean="0"/>
              <a:t>7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254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06A6D-703C-47E3-AB2B-8F967FF44E47}" type="datetime1">
              <a:rPr lang="en-US" smtClean="0"/>
              <a:t>7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550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A9DD9-230F-4C99-AF52-F8A97146911C}" type="datetime1">
              <a:rPr lang="en-US" smtClean="0"/>
              <a:t>7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528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DE465-2789-483E-8435-FD47CF1BED0F}" type="datetime1">
              <a:rPr lang="en-US" smtClean="0"/>
              <a:t>7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095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2E380-8248-4A8C-B51D-9025AD665328}" type="datetime1">
              <a:rPr lang="en-US" smtClean="0"/>
              <a:t>7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216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246D7-5434-4704-B200-A2CCB3095FD8}" type="datetime1">
              <a:rPr lang="en-US" smtClean="0"/>
              <a:t>7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833D5-4D11-42A4-9D43-299DDC378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605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4"/>
          <p:cNvSpPr>
            <a:spLocks noGrp="1"/>
          </p:cNvSpPr>
          <p:nvPr>
            <p:ph idx="1"/>
          </p:nvPr>
        </p:nvSpPr>
        <p:spPr>
          <a:xfrm>
            <a:off x="965915" y="309093"/>
            <a:ext cx="10612192" cy="6220496"/>
          </a:xfr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noAutofit/>
          </a:bodyPr>
          <a:lstStyle/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versity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Gondar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titute of Biotechnology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Environmental and Industrial Biotechnology </a:t>
            </a: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inar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rent trends in the search for clinically important microbial L-asparaginases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isor: Prof. </a:t>
            </a: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rhanu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ualem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ndu Nibret Tsegaye </a:t>
            </a: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hD student, Industrial Biotechnology)</a:t>
            </a:r>
          </a:p>
          <a:p>
            <a:pPr marL="0" indent="0" algn="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ember, 2022</a:t>
            </a:r>
          </a:p>
          <a:p>
            <a:pPr marL="0" indent="0" algn="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ndar, Ethiopia</a:t>
            </a:r>
          </a:p>
        </p:txBody>
      </p:sp>
      <p:pic>
        <p:nvPicPr>
          <p:cNvPr id="9" name="Picture 8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833870" y="309094"/>
            <a:ext cx="2176530" cy="1429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7234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888642" y="171943"/>
            <a:ext cx="7886700" cy="472001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000" b="1" dirty="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inically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… 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88642" y="746975"/>
            <a:ext cx="10509161" cy="5808372"/>
          </a:xfrm>
        </p:spPr>
        <p:txBody>
          <a:bodyPr/>
          <a:lstStyle/>
          <a:p>
            <a:r>
              <a:rPr lang="en-US" dirty="0"/>
              <a:t> </a:t>
            </a:r>
            <a:r>
              <a:rPr lang="en-US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oxicity</a:t>
            </a:r>
            <a:r>
              <a:rPr lang="en-US" sz="3200" dirty="0" smtClean="0"/>
              <a:t>  </a:t>
            </a:r>
            <a:endParaRPr lang="en-US" dirty="0" smtClean="0"/>
          </a:p>
          <a:p>
            <a:pPr>
              <a:buFont typeface="Courier New" panose="02070309020205020404" pitchFamily="49" charset="0"/>
              <a:buChar char="o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ither related to: 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- Hypersensitivity to the foreign protein or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- Secondary L-glutaminase activity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; Fonseca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;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pon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2) </a:t>
            </a:r>
          </a:p>
          <a:p>
            <a:pPr marL="0" indent="0">
              <a:buNone/>
            </a:pP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taminase coactivity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Glutamine             glutamat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24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monia </a:t>
            </a:r>
            <a:endParaRPr lang="en-US" sz="2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Liver dysfunction and neurotoxicity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pon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2) </a:t>
            </a:r>
          </a:p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rease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Urea          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moni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carb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oxide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ammonemia - causes brain injury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shok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19)</a:t>
            </a:r>
          </a:p>
        </p:txBody>
      </p:sp>
      <p:sp>
        <p:nvSpPr>
          <p:cNvPr id="5" name="Right Arrow 4"/>
          <p:cNvSpPr/>
          <p:nvPr/>
        </p:nvSpPr>
        <p:spPr>
          <a:xfrm>
            <a:off x="2116428" y="5473521"/>
            <a:ext cx="772732" cy="14166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6" name="Right Arrow 5"/>
          <p:cNvSpPr/>
          <p:nvPr/>
        </p:nvSpPr>
        <p:spPr>
          <a:xfrm>
            <a:off x="2799007" y="4121241"/>
            <a:ext cx="708339" cy="10303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456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4146" y="197701"/>
            <a:ext cx="7886700" cy="549274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y exogenous sources of L-asparaginases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4146" y="908587"/>
            <a:ext cx="11007144" cy="5447763"/>
          </a:xfrm>
        </p:spPr>
        <p:txBody>
          <a:bodyPr>
            <a:normAutofit/>
          </a:bodyPr>
          <a:lstStyle/>
          <a:p>
            <a:r>
              <a:rPr lang="en-US" dirty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s -  type III (N-terminal nucleophile-amidohydrolase)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Nase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Exhibit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</a:t>
            </a:r>
            <a:r>
              <a:rPr lang="en-US" sz="2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K</a:t>
            </a:r>
            <a:r>
              <a:rPr lang="en-US" sz="2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2.9mM;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ais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De Souza,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21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Complete depletion of asparagine in blood require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µm K</a:t>
            </a:r>
            <a:r>
              <a:rPr lang="en-US" sz="2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sparagin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ouin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17) </a:t>
            </a: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=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orly suited for therapeutic applications </a:t>
            </a:r>
          </a:p>
          <a:p>
            <a:pPr marL="0" indent="0">
              <a:buNone/>
            </a:pP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 II L-ASNases from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ckeya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ysanthemi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rmerly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hrysanthem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  <a:p>
            <a:pPr>
              <a:buFont typeface="Courier New" panose="02070309020205020404" pitchFamily="49" charset="0"/>
              <a:buChar char="o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treatment of ALL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Courier New" panose="02070309020205020404" pitchFamily="49" charset="0"/>
              <a:buChar char="o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iminat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irculating asparagine efficientl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Courier New" panose="02070309020205020404" pitchFamily="49" charset="0"/>
              <a:buChar char="o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ly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sy to produc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dadiya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; Andrade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)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3097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0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3" dur="50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6" dur="500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9" dur="500"/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399" y="313612"/>
            <a:ext cx="9438336" cy="613667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netic parameters of L-asparaginases in recent publications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399" y="1313647"/>
            <a:ext cx="10689465" cy="4262905"/>
          </a:xfrm>
        </p:spPr>
        <p:txBody>
          <a:bodyPr>
            <a:norm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e to the drawback of the current commercialized L-ASNase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vel enzymes are required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Tx/>
              <a:buChar char="-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earch must include V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K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eckett and Gervais, 2019)</a:t>
            </a:r>
          </a:p>
          <a:p>
            <a:pPr marL="0" indent="0" algn="just">
              <a:buNone/>
            </a:pPr>
            <a:endParaRPr lang="en-US" sz="2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buFontTx/>
              <a:buChar char="-"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bes are preferred over plant and animal sources </a:t>
            </a:r>
          </a:p>
          <a:p>
            <a:pPr algn="just">
              <a:buFont typeface="Courier New" panose="02070309020205020404" pitchFamily="49" charset="0"/>
              <a:buChar char="o"/>
            </a:pP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Bacteria 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buFont typeface="Courier New" panose="02070309020205020404" pitchFamily="49" charset="0"/>
              <a:buChar char="o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ngi 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buFontTx/>
              <a:buChar char="-"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026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1972" y="184823"/>
            <a:ext cx="7886700" cy="433364"/>
          </a:xfr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>
            <a:normAutofit fontScale="90000"/>
          </a:bodyPr>
          <a:lstStyle/>
          <a:p>
            <a:r>
              <a:rPr lang="en-US" sz="2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l type-II L-asparaginas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206062" y="730921"/>
            <a:ext cx="11616744" cy="4351338"/>
          </a:xfrm>
        </p:spPr>
        <p:txBody>
          <a:bodyPr/>
          <a:lstStyle/>
          <a:p>
            <a:pPr marL="0" indent="0">
              <a:buNone/>
            </a:pPr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Kinetic parameters and other characteristics of bacterial L-asparaginases in recent publications </a:t>
            </a:r>
          </a:p>
          <a:p>
            <a:pPr mar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lum bright="2000"/>
          </a:blip>
          <a:stretch>
            <a:fillRect/>
          </a:stretch>
        </p:blipFill>
        <p:spPr>
          <a:xfrm>
            <a:off x="206062" y="1149807"/>
            <a:ext cx="11768410" cy="4555533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206062" y="5705340"/>
            <a:ext cx="65811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DPPH - 2, 2 diphenyl-1-picrylhydrazyl </a:t>
            </a:r>
            <a:endParaRPr lang="en-US" sz="28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 ABTS - 2, 2’-azino-bis (3-ethylbenzothiazoline-6-sulfonic acid</a:t>
            </a:r>
            <a:endParaRPr lang="en-US" sz="2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522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8651" y="159507"/>
            <a:ext cx="10515600" cy="446244"/>
          </a:xfr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s from Fungi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3375" y="717412"/>
            <a:ext cx="11654307" cy="4351338"/>
          </a:xfrm>
        </p:spPr>
        <p:txBody>
          <a:bodyPr/>
          <a:lstStyle/>
          <a:p>
            <a:pPr marL="0" indent="0">
              <a:buNone/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: 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s of fungal L-asparaginases in recent research publications </a:t>
            </a:r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lum bright="1000"/>
          </a:blip>
          <a:stretch>
            <a:fillRect/>
          </a:stretch>
        </p:blipFill>
        <p:spPr>
          <a:xfrm>
            <a:off x="223375" y="1174503"/>
            <a:ext cx="11831250" cy="5364409"/>
          </a:xfrm>
          <a:prstGeom prst="rect">
            <a:avLst/>
          </a:prstGeom>
        </p:spPr>
      </p:pic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526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896" y="141667"/>
            <a:ext cx="9825507" cy="489397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going effor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4713" y="785610"/>
            <a:ext cx="11409609" cy="5679583"/>
          </a:xfrm>
        </p:spPr>
        <p:txBody>
          <a:bodyPr>
            <a:normAutofit fontScale="92500" lnSpcReduction="10000"/>
          </a:bodyPr>
          <a:lstStyle/>
          <a:p>
            <a:r>
              <a:rPr lang="en-US" sz="2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.coli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AII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ype II ASNase - first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oice- drug </a:t>
            </a:r>
          </a:p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hrysanthemi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II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used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y in cases of immune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ctions </a:t>
            </a:r>
          </a:p>
          <a:p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awbacks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High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tability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Short half-life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Need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al administrations to obtain effective treatment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(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gi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7, </a:t>
            </a:r>
            <a:r>
              <a:rPr lang="en-US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dadiya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, 2020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  <a:p>
            <a:r>
              <a:rPr lang="en-US" sz="2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ies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 Structural modification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 Recombinant ASNase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 Encapsulation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 Search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new ASNase-producing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bes, etc.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</a:t>
            </a:r>
            <a:r>
              <a:rPr lang="en-US" sz="2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bat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; </a:t>
            </a:r>
            <a:r>
              <a:rPr lang="en-US" sz="2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lén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; </a:t>
            </a:r>
            <a:r>
              <a:rPr lang="en-US" sz="2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íaz-Barriga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</a:t>
            </a:r>
            <a:r>
              <a:rPr lang="en-US" sz="2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958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3045" y="159063"/>
            <a:ext cx="10515600" cy="523517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Recombinant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Nase</a:t>
            </a:r>
            <a:endParaRPr lang="en-US" sz="2400" b="1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9805" y="682580"/>
            <a:ext cx="11529818" cy="5898068"/>
          </a:xfrm>
          <a:prstGeom prst="rect">
            <a:avLst/>
          </a:prstGeom>
        </p:spPr>
      </p:pic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922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8651" y="159063"/>
            <a:ext cx="10515600" cy="394729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 fontScale="90000"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ombinant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…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58651" y="649819"/>
            <a:ext cx="11799412" cy="153958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651" y="2189408"/>
            <a:ext cx="11799411" cy="3020452"/>
          </a:xfrm>
          <a:prstGeom prst="rect">
            <a:avLst/>
          </a:prstGeom>
        </p:spPr>
      </p:pic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212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852" y="146186"/>
            <a:ext cx="10805374" cy="433363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400" b="1" dirty="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ison</a:t>
            </a:r>
            <a:r>
              <a:rPr lang="en-US" sz="2400" dirty="0"/>
              <a:t>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L-ASNases from different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s based on Km values 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Content Placeholder 8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40757225"/>
              </p:ext>
            </p:extLst>
          </p:nvPr>
        </p:nvGraphicFramePr>
        <p:xfrm>
          <a:off x="193183" y="759854"/>
          <a:ext cx="11809927" cy="56280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567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470" y="171943"/>
            <a:ext cx="10515600" cy="536396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/>
          <a:lstStyle/>
          <a:p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Encapsulation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0470" y="850006"/>
            <a:ext cx="11370972" cy="5563673"/>
          </a:xfrm>
        </p:spPr>
        <p:txBody>
          <a:bodyPr/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ct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-ASNase from proteases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hance pharmacokinetic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file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imarães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2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uce immunogenicity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illanueva-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res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  <a:p>
            <a:pPr marL="0" indent="0">
              <a:buNone/>
            </a:pP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Wingdings" panose="05000000000000000000" pitchFamily="2" charset="2"/>
              <a:buChar char="v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akambari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8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Encapsulated L-ASN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illus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quilensis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9W into </a:t>
            </a:r>
            <a:r>
              <a:rPr lang="en-US" sz="24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lid lipid </a:t>
            </a:r>
            <a:r>
              <a:rPr lang="en-US" sz="2400" b="1" dirty="0" smtClean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ticles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= Improv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max (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79 to 10.21),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m reduced by half (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70 to 0.04)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= improv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lf-life (50.19min to 120.56min), and stable for 25 days at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sz="2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</a:p>
          <a:p>
            <a:pPr marL="0" indent="0">
              <a:buNone/>
            </a:pPr>
            <a:endPara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íaz-Barriga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21: </a:t>
            </a: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- Encapsulated ASN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from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o </a:t>
            </a:r>
            <a:r>
              <a:rPr lang="en-US" sz="24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rus-Like Protein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bacteriophage P22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-fold and a 2-fold increase i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cat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083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7744" y="262095"/>
            <a:ext cx="10515600" cy="510638"/>
          </a:xfrm>
        </p:spPr>
        <p:txBody>
          <a:bodyPr>
            <a:noAutofit/>
          </a:bodyPr>
          <a:lstStyle/>
          <a:p>
            <a:r>
              <a:rPr lang="en-US" sz="2800" b="1" dirty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utline</a:t>
            </a:r>
            <a:r>
              <a:rPr lang="en-US" sz="4800" dirty="0" smtClean="0"/>
              <a:t> </a:t>
            </a:r>
            <a:endParaRPr lang="en-US" sz="48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7744" y="953037"/>
            <a:ext cx="10786056" cy="5223926"/>
          </a:xfrm>
        </p:spPr>
        <p:txBody>
          <a:bodyPr/>
          <a:lstStyle/>
          <a:p>
            <a:r>
              <a:rPr lang="en-US" dirty="0" smtClean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oduction</a:t>
            </a:r>
            <a:r>
              <a:rPr lang="en-US" dirty="0" smtClean="0"/>
              <a:t>  </a:t>
            </a:r>
          </a:p>
          <a:p>
            <a:r>
              <a:rPr lang="en-US" dirty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s used in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s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inically important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s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y exogenous sources of L-asparaginases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etic parameters of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bial L-asparaginase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recent publications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- Bacterial L-asparaginases </a:t>
            </a: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- L-asparaginase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gi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going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orts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 related research in Ethiopia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9923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7591" y="210579"/>
            <a:ext cx="10515600" cy="523517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 smtClean="0">
                <a:solidFill>
                  <a:schemeClr val="lt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 Site-directed </a:t>
            </a:r>
            <a:r>
              <a:rPr lang="en-US" sz="2800" b="1" dirty="0">
                <a:solidFill>
                  <a:schemeClr val="lt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utagenesis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7591" y="872587"/>
            <a:ext cx="11152032" cy="5309271"/>
          </a:xfrm>
        </p:spPr>
        <p:txBody>
          <a:bodyPr/>
          <a:lstStyle/>
          <a:p>
            <a:r>
              <a:rPr lang="en-US" dirty="0" smtClean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to improv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-ASN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bility, immunogenicity, and substrate specificit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i </a:t>
            </a:r>
            <a:r>
              <a:rPr lang="en-US" sz="2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, (2017)</a:t>
            </a: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- Show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t residue </a:t>
            </a:r>
            <a:r>
              <a:rPr lang="en-US" sz="24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n24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y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l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tabilizing the activ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=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24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t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-term storage stability, and resistance to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ase </a:t>
            </a:r>
          </a:p>
          <a:p>
            <a:pPr marL="0" indent="0">
              <a:buNone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549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8803" y="210579"/>
            <a:ext cx="10515600" cy="484881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 smtClean="0">
                <a:solidFill>
                  <a:schemeClr val="lt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. Structure-based </a:t>
            </a:r>
            <a:r>
              <a:rPr lang="en-US" sz="2800" b="1" dirty="0">
                <a:solidFill>
                  <a:schemeClr val="lt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ational desig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8803" y="927278"/>
            <a:ext cx="11461124" cy="5409127"/>
          </a:xfrm>
        </p:spPr>
        <p:txBody>
          <a:bodyPr>
            <a:norm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gineering approach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utational tool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improve screening efficiency in th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o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tio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s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hou </a:t>
            </a:r>
            <a:r>
              <a:rPr lang="en-US" sz="2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22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Us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informatics server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screen mutation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specific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s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prov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talytic activity of type II ASNase from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illus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cheniformis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m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uc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1.45mM from 2.33mM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* Kcat increas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778.87 min</a:t>
            </a:r>
            <a:r>
              <a:rPr lang="en-US" sz="2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7.95min</a:t>
            </a:r>
            <a:r>
              <a:rPr lang="en-US" sz="2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</a:p>
          <a:p>
            <a:pPr marL="0" indent="0">
              <a:buNone/>
            </a:pPr>
            <a:endParaRPr lang="en-US" sz="2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 </a:t>
            </a:r>
            <a:r>
              <a:rPr lang="en-US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22 </a:t>
            </a:r>
          </a:p>
          <a:p>
            <a:pPr marL="0" indent="0">
              <a:buNone/>
            </a:pPr>
            <a:r>
              <a:rPr lang="en-US" sz="24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Developed thermostable L-ASNase from B. licheniformis using rational design (free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ergy, structural and conservative analysis)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272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4561" y="171941"/>
            <a:ext cx="10515600" cy="459123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Autofit/>
          </a:bodyPr>
          <a:lstStyle/>
          <a:p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In </a:t>
            </a: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lico screen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4561" y="798490"/>
            <a:ext cx="11512639" cy="5666704"/>
          </a:xfrm>
        </p:spPr>
        <p:txBody>
          <a:bodyPr/>
          <a:lstStyle/>
          <a:p>
            <a:r>
              <a:rPr lang="en-US" dirty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mics data provide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portunity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computational prediction of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ugs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3D structure of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zyme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ir substrates - allows to analyze their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 </a:t>
            </a:r>
          </a:p>
          <a:p>
            <a:pPr marL="0" indent="0">
              <a:buNone/>
            </a:pP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; Li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al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20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nB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p.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hav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er binding energy than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ysanthemi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marL="0" indent="0">
              <a:buNone/>
            </a:pP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*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iseus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3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cal/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*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ezuelae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2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cal/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*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eptomyces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inus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3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cal/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  <a:p>
            <a:pPr marL="0" indent="0">
              <a:buNone/>
            </a:pP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6222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259" y="231820"/>
            <a:ext cx="8743682" cy="566671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lico </a:t>
            </a:r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… </a:t>
            </a:r>
            <a:endParaRPr lang="en-US" sz="28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9259" y="1094704"/>
            <a:ext cx="11074758" cy="5261645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-</a:t>
            </a: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hbani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hosale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20)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sarium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ani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R-36 binding energy - 6.85kcal/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delrazek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2019)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the antigenic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s of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-ASNase of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illus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cheniformis </a:t>
            </a:r>
          </a:p>
          <a:p>
            <a:pPr marL="0" indent="0">
              <a:buNone/>
            </a:pP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i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18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ysanthemi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16</a:t>
            </a:r>
          </a:p>
          <a:p>
            <a:pPr marL="0" indent="0">
              <a:buNone/>
            </a:pP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 Bacillus licheniformi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17 </a:t>
            </a:r>
          </a:p>
          <a:p>
            <a:pPr marL="0" indent="0">
              <a:buNone/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haeepoor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2018)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 i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lico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lection N248S mutant with reduced glutaminase activity and confirmed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experimental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361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349" y="159064"/>
            <a:ext cx="10515600" cy="497760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Searching </a:t>
            </a: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el L-Asparaginas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3349" y="798490"/>
            <a:ext cx="11242183" cy="5512158"/>
          </a:xfrm>
        </p:spPr>
        <p:txBody>
          <a:bodyPr/>
          <a:lstStyle/>
          <a:p>
            <a:r>
              <a:rPr lang="en-US" dirty="0" smtClean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ss exploit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s 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ine environments – similar salinity to human serum 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remophiles  - industrial-like conditions  </a:t>
            </a:r>
          </a:p>
          <a:p>
            <a:pPr marL="0" indent="0">
              <a:buNone/>
            </a:pP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min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21: 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erthermophilic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chaeon,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mococcus </a:t>
            </a:r>
            <a:r>
              <a:rPr lang="en-US" sz="2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biricus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marL="0" indent="0">
              <a:buNone/>
            </a:pP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*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m = 2.8mM, Vmax = 1200 µM/min </a:t>
            </a:r>
          </a:p>
          <a:p>
            <a:pPr marL="0" indent="0">
              <a:buNone/>
            </a:pP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-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kharany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., 2020: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cillus </a:t>
            </a:r>
            <a:r>
              <a:rPr lang="en-US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lotolerans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HEM18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* Km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47M, Vmax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92.74</a:t>
            </a:r>
          </a:p>
          <a:p>
            <a:pPr marL="0" indent="0">
              <a:buNone/>
            </a:pP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ed or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ent glutaminase/urease activity (Tables 2 and 3)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174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893" y="184822"/>
            <a:ext cx="10515600" cy="472002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 fontScale="90000"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 related research in Ethiopia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2893" y="862885"/>
            <a:ext cx="11370972" cy="5314078"/>
          </a:xfrm>
        </p:spPr>
        <p:txBody>
          <a:bodyPr/>
          <a:lstStyle/>
          <a:p>
            <a:r>
              <a:rPr lang="en-US" dirty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wedew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22: National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urden and trend of cancer i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iopia, 2010 – 2019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imat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,560 new incident cases and 39,480 death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e to cancer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9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Most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mon cancer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idences: leukemi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ervical, breast, colon and rectum, and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stomach cancers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Most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thal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s: leukemi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reast, cervical, and stomach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s </a:t>
            </a:r>
          </a:p>
          <a:p>
            <a:pPr marL="0" indent="0">
              <a:buNone/>
            </a:pPr>
            <a:endParaRPr lang="en-US" sz="2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 burden reduction – one of the SDG </a:t>
            </a:r>
          </a:p>
          <a:p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ional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control pla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2016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20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MOH, 2020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  <a:p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2638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7439" y="197699"/>
            <a:ext cx="9915660" cy="549275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related research in Ethiopia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439" y="940158"/>
            <a:ext cx="10966361" cy="4919729"/>
          </a:xfrm>
        </p:spPr>
        <p:txBody>
          <a:bodyPr/>
          <a:lstStyle/>
          <a:p>
            <a:r>
              <a:rPr lang="en-US" dirty="0" smtClean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cus on: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P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ventiv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actices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ntie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22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Childhoo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prevalence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alamaw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Effect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hemotherapy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ondmeneh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konnen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22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Incidenc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rend of hematological malignancy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awgaw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 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Magnitude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emporal trends of chronic myeloid leukemia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u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1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Risk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ctors for chronic lymphocytic leukemia progression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sia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2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Challenge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pportunitie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ncology service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ileselassie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19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c. </a:t>
            </a:r>
          </a:p>
          <a:p>
            <a:pPr marL="0" indent="0">
              <a:buNone/>
            </a:pP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est of my knowledge,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anticancer enzymes in Ethiopia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4295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7592" y="197700"/>
            <a:ext cx="10515600" cy="729579"/>
          </a:xfrm>
        </p:spPr>
        <p:txBody>
          <a:bodyPr/>
          <a:lstStyle/>
          <a:p>
            <a: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lusion 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7592" y="927279"/>
            <a:ext cx="10876208" cy="5249684"/>
          </a:xfrm>
        </p:spPr>
        <p:txBody>
          <a:bodyPr/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-asparaginase discover still remained as a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esting research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ic, despite its long history of discovery. </a:t>
            </a:r>
          </a:p>
          <a:p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arious strategies are undertaking to meet the unmet needs of L-asparaginases. 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mics data and novel searching strategies may help to unravel the challenges in the search for therapeutically </a:t>
            </a:r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portant L-ASNases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257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knowledgments </a:t>
            </a:r>
            <a:endParaRPr 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lnSpc>
                <a:spcPct val="100000"/>
              </a:lnSpc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niversity of Gondar </a:t>
            </a:r>
          </a:p>
          <a:p>
            <a:pPr>
              <a:lnSpc>
                <a:spcPct val="100000"/>
              </a:lnSpc>
            </a:pP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f.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rhanu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ualem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dvisor  </a:t>
            </a:r>
          </a:p>
          <a:p>
            <a:pPr>
              <a:lnSpc>
                <a:spcPct val="100000"/>
              </a:lnSpc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leagues 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205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12443" y="988498"/>
            <a:ext cx="10515600" cy="4351338"/>
          </a:xfrm>
        </p:spPr>
        <p:txBody>
          <a:bodyPr/>
          <a:lstStyle/>
          <a:p>
            <a:pPr marL="0" indent="0" algn="ctr">
              <a:buNone/>
            </a:pPr>
            <a:endParaRPr lang="en-US" dirty="0" smtClean="0"/>
          </a:p>
          <a:p>
            <a:pPr marL="0" indent="0" algn="ctr">
              <a:buNone/>
            </a:pPr>
            <a:endParaRPr lang="en-US" dirty="0"/>
          </a:p>
          <a:p>
            <a:pPr marL="0" indent="0" algn="ctr">
              <a:buNone/>
            </a:pPr>
            <a:endParaRPr lang="en-US" dirty="0" smtClean="0"/>
          </a:p>
          <a:p>
            <a:pPr marL="0" indent="0" algn="ctr">
              <a:buNone/>
            </a:pPr>
            <a:endParaRPr lang="en-US" dirty="0"/>
          </a:p>
          <a:p>
            <a:pPr marL="0" indent="0" algn="ctr">
              <a:buNone/>
            </a:pPr>
            <a:r>
              <a:rPr lang="en-US" sz="7200" dirty="0" smtClean="0">
                <a:latin typeface="Adobe Garamond Pro Bold" panose="02020702060506020403" pitchFamily="18" charset="0"/>
              </a:rPr>
              <a:t>Thank you! </a:t>
            </a:r>
            <a:endParaRPr lang="en-US" sz="7200" dirty="0">
              <a:latin typeface="Adobe Garamond Pro Bold" panose="02020702060506020403" pitchFamily="18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731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7127" y="159065"/>
            <a:ext cx="7886700" cy="459122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 fontScale="90000"/>
          </a:bodyPr>
          <a:lstStyle/>
          <a:p>
            <a:r>
              <a:rPr lang="en-US" sz="3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oduction 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7127" y="798489"/>
            <a:ext cx="10534917" cy="5615188"/>
          </a:xfrm>
        </p:spPr>
        <p:txBody>
          <a:bodyPr>
            <a:normAutofit/>
          </a:bodyPr>
          <a:lstStyle/>
          <a:p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no acid deprivation therapy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Evolve as a promising strategy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 Relies on difference i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sm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/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and normal cells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ncer cells </a:t>
            </a:r>
            <a:r>
              <a:rPr lang="en-US" sz="2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i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th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Reduced expression of certain enzymes (e.g. asparaginas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thetase) 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Auxotrophy for some specific amino acids  </a:t>
            </a:r>
          </a:p>
          <a:p>
            <a:pPr marL="0" indent="0">
              <a:buNone/>
            </a:pP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no acid depletion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Selectively inhibits tumor cells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 Normal cells unaffected   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898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577" y="210579"/>
            <a:ext cx="10515600" cy="459123"/>
          </a:xfrm>
        </p:spPr>
        <p:txBody>
          <a:bodyPr>
            <a:noAutofit/>
          </a:bodyPr>
          <a:lstStyle/>
          <a:p>
            <a:r>
              <a:rPr lang="en-US" sz="2800" b="1" dirty="0" smtClean="0">
                <a:latin typeface="Adobe Garamond Pro" panose="02020502060506020403" pitchFamily="18" charset="0"/>
              </a:rPr>
              <a:t>History of L-asparaginase</a:t>
            </a:r>
            <a:endParaRPr lang="en-US" sz="2800" b="1" dirty="0">
              <a:latin typeface="Adobe Garamond Pro" panose="02020502060506020403" pitchFamily="18" charset="0"/>
            </a:endParaRPr>
          </a:p>
        </p:txBody>
      </p:sp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4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7577" y="972355"/>
            <a:ext cx="11771291" cy="515154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04551" y="6426558"/>
            <a:ext cx="60015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/>
              <a:t>Loch and </a:t>
            </a:r>
            <a:r>
              <a:rPr lang="en-US" sz="2000" dirty="0" err="1" smtClean="0"/>
              <a:t>Jaskolskib</a:t>
            </a:r>
            <a:r>
              <a:rPr lang="en-US" sz="2000" dirty="0" smtClean="0"/>
              <a:t>, </a:t>
            </a:r>
            <a:r>
              <a:rPr lang="en-US" sz="2000" dirty="0"/>
              <a:t>2021, </a:t>
            </a:r>
            <a:r>
              <a:rPr lang="en-US" sz="2000" dirty="0" err="1"/>
              <a:t>IUCrJ</a:t>
            </a:r>
            <a:r>
              <a:rPr lang="en-US" sz="2000" dirty="0"/>
              <a:t> (2021). 8, 514–531  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243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0" y="287854"/>
            <a:ext cx="7886700" cy="523516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apeutic</a:t>
            </a:r>
            <a:r>
              <a:rPr lang="en-US" sz="2800" dirty="0"/>
              <a:t> </a:t>
            </a: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zymes for cancer trea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940159"/>
            <a:ext cx="10444766" cy="5228821"/>
          </a:xfrm>
        </p:spPr>
        <p:txBody>
          <a:bodyPr>
            <a:norm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</a:t>
            </a:r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lready in use in the clinics  </a:t>
            </a:r>
          </a:p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ginine deiminase and </a:t>
            </a:r>
            <a:r>
              <a:rPr lang="en-US" sz="2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ionase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under clinical trials</a:t>
            </a:r>
          </a:p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ysine oxidase, glutaminase, and phenylalanine ammonia-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sz="2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ase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- potential therapeutic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hankhar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)</a:t>
            </a:r>
          </a:p>
          <a:p>
            <a:pPr marL="0" indent="0">
              <a:buNone/>
            </a:pP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- Essential Medicines as a cytotoxic medicine for acute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lymphoblastic leukemia - ALL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WHO, 2021)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U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controlled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feration of immature lymphocyt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862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7431" y="287853"/>
            <a:ext cx="7886700" cy="523516"/>
          </a:xfrm>
        </p:spPr>
        <p:txBody>
          <a:bodyPr>
            <a:no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 (EC 3.5.1.1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01521" y="1352281"/>
            <a:ext cx="10431887" cy="4056846"/>
          </a:xfrm>
        </p:spPr>
        <p:txBody>
          <a:bodyPr/>
          <a:lstStyle/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dohydrolase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L-asparagine             aspartic acid + ammonia  </a:t>
            </a:r>
            <a:endParaRPr lang="en-US" sz="2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-  Lowers L-Asparagine in plasma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-  Starves tumor cells </a:t>
            </a:r>
          </a:p>
          <a:p>
            <a:pPr marL="0" indent="0">
              <a:buNone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s of L-asparaginase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-  Medicine – cancer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-  Food industry – reduce acrylamide production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marL="0" indent="0">
              <a:buNone/>
            </a:pPr>
            <a:endParaRPr lang="en-US" sz="2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ight Arrow 3"/>
          <p:cNvSpPr/>
          <p:nvPr/>
        </p:nvSpPr>
        <p:spPr>
          <a:xfrm>
            <a:off x="5853448" y="1532586"/>
            <a:ext cx="759853" cy="167425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507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940159" y="171944"/>
            <a:ext cx="7886700" cy="549274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 sources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40159" y="862883"/>
            <a:ext cx="10419008" cy="5203066"/>
          </a:xfrm>
        </p:spPr>
        <p:txBody>
          <a:bodyPr>
            <a:normAutofit/>
          </a:bodyPr>
          <a:lstStyle/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 domains of life </a:t>
            </a:r>
            <a:endParaRPr lang="en-US" sz="2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 </a:t>
            </a:r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 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chaea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ukaryotes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gi, algae, animals, and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nee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0)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robes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preferred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rces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- Industrial production 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- Desirable properties  </a:t>
            </a:r>
            <a:endParaRPr lang="en-US" sz="2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ustrial production of L-asparaginase </a:t>
            </a:r>
          </a:p>
          <a:p>
            <a:pPr marL="0" indent="0">
              <a:buNone/>
            </a:pP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- </a:t>
            </a:r>
            <a:r>
              <a:rPr lang="en-US" sz="2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2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2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hrysanthemi</a:t>
            </a:r>
          </a:p>
          <a:p>
            <a:pPr marL="0" indent="0">
              <a:buNone/>
            </a:pPr>
            <a:endParaRPr lang="en-US" sz="2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4331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398" y="185693"/>
            <a:ext cx="7886700" cy="549274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paraginases used in the clinic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9398" y="1068950"/>
            <a:ext cx="11384923" cy="4726544"/>
          </a:xfrm>
        </p:spPr>
        <p:txBody>
          <a:bodyPr>
            <a:normAutofit/>
          </a:bodyPr>
          <a:lstStyle/>
          <a:p>
            <a:r>
              <a:rPr lang="en-US" sz="2400" dirty="0"/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winase</a:t>
            </a:r>
            <a:r>
              <a:rPr lang="en-US" sz="2400" dirty="0"/>
              <a:t>®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ylaz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   -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winia chrysanthemi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tive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ASNase -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spa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rolas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il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</a:p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mulations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-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aspa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parlas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 </a:t>
            </a:r>
            <a:r>
              <a:rPr lang="en-US" sz="2000" dirty="0"/>
              <a:t>(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mpon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22)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lum bright="1000"/>
          </a:blip>
          <a:stretch>
            <a:fillRect/>
          </a:stretch>
        </p:blipFill>
        <p:spPr>
          <a:xfrm>
            <a:off x="208251" y="2936924"/>
            <a:ext cx="11666070" cy="195705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8353025" y="5061401"/>
            <a:ext cx="307327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eckett and Gervais, 2019)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7705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155" y="236341"/>
            <a:ext cx="7886700" cy="484880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ally important L-asparaginas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5308" y="965918"/>
            <a:ext cx="11037194" cy="4906848"/>
          </a:xfrm>
        </p:spPr>
        <p:txBody>
          <a:bodyPr/>
          <a:lstStyle/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haelis constant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</a:p>
          <a:p>
            <a:pPr>
              <a:buFontTx/>
              <a:buChar char="-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rnover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Kcat</a:t>
            </a:r>
          </a:p>
          <a:p>
            <a:pPr>
              <a:buFontTx/>
              <a:buChar char="-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ximum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locity  - Vmax  </a:t>
            </a:r>
          </a:p>
          <a:p>
            <a:pPr marL="0" indent="0">
              <a:buNone/>
            </a:pP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24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 the concentration of substrat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half of the maximum reaction rate</a:t>
            </a: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- Low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2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µM) – requir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rnover number (K</a:t>
            </a:r>
            <a:r>
              <a:rPr lang="en-US" sz="2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mber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substrates converted to a product by a single molecule of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zyme/time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-  K</a:t>
            </a:r>
            <a:r>
              <a:rPr lang="en-US" sz="2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Vmax/[enzyme]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2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hieved when enzyme’s active site is fully occupied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8492226" y="1946683"/>
            <a:ext cx="313739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eckett and Gervais (2019</a:t>
            </a:r>
            <a:r>
              <a:rPr lang="en-US" sz="2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</a:t>
            </a:r>
            <a:endParaRPr lang="en-US" sz="2000" dirty="0"/>
          </a:p>
        </p:txBody>
      </p:sp>
      <p:cxnSp>
        <p:nvCxnSpPr>
          <p:cNvPr id="6" name="Straight Connector 5"/>
          <p:cNvCxnSpPr/>
          <p:nvPr/>
        </p:nvCxnSpPr>
        <p:spPr>
          <a:xfrm flipV="1">
            <a:off x="631065" y="2408349"/>
            <a:ext cx="10998558" cy="257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5550794" y="1040802"/>
            <a:ext cx="35674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Glutamin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</a:t>
            </a:r>
          </a:p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Toxicity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4790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0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3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6" presetClass="entr" presetSubtype="2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6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21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26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7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29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0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32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3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35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6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38" dur="500"/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9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41" dur="500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901521" y="159063"/>
            <a:ext cx="7886700" cy="433365"/>
          </a:xfr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>
            <a:norm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ally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…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01521" y="940157"/>
            <a:ext cx="10805375" cy="4752305"/>
          </a:xfrm>
        </p:spPr>
        <p:txBody>
          <a:bodyPr>
            <a:normAutofit/>
          </a:bodyPr>
          <a:lstStyle/>
          <a:p>
            <a:r>
              <a:rPr lang="en-US" dirty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r>
              <a:rPr lang="en-US" dirty="0" smtClean="0"/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Glutaminase activit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Conflicting evidenc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Courier New" panose="02070309020205020404" pitchFamily="49" charset="0"/>
              <a:buChar char="o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guy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2018 = low glutaminas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high efficacy against ALL </a:t>
            </a:r>
          </a:p>
          <a:p>
            <a:pPr>
              <a:buFont typeface="Courier New" panose="02070309020205020404" pitchFamily="49" charset="0"/>
              <a:buChar char="o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s 2 and 3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Wingdings" panose="05000000000000000000" pitchFamily="2" charset="2"/>
              <a:buChar char="§"/>
            </a:pPr>
            <a:endParaRPr lang="en-US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han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, 2019 =  glutaminase activity required for ASNase activity/Model mice </a:t>
            </a:r>
          </a:p>
          <a:p>
            <a:pPr>
              <a:buFont typeface="Wingdings" panose="05000000000000000000" pitchFamily="2" charset="2"/>
              <a:buChar char="§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guyn </a:t>
            </a:r>
            <a:r>
              <a:rPr lang="en-US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.al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, 2017 = single-point mutation determines substrat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vity (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o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: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ne at position 121 - Glutaminase activity </a:t>
            </a:r>
          </a:p>
          <a:p>
            <a:pPr marL="0" indent="0">
              <a:buNone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ne at position 121 - no glutaminase activity 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833D5-4D11-42A4-9D43-299DDC3782C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4978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03</TotalTime>
  <Words>1755</Words>
  <Application>Microsoft Office PowerPoint</Application>
  <PresentationFormat>Widescreen</PresentationFormat>
  <Paragraphs>298</Paragraphs>
  <Slides>3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9" baseType="lpstr">
      <vt:lpstr>Adobe Garamond Pro</vt:lpstr>
      <vt:lpstr>Adobe Garamond Pro Bold</vt:lpstr>
      <vt:lpstr>Arial</vt:lpstr>
      <vt:lpstr>Calibri</vt:lpstr>
      <vt:lpstr>Calibri Light</vt:lpstr>
      <vt:lpstr>Courier New</vt:lpstr>
      <vt:lpstr>Times New Roman</vt:lpstr>
      <vt:lpstr>Wingdings</vt:lpstr>
      <vt:lpstr>Office Theme</vt:lpstr>
      <vt:lpstr>PowerPoint Presentation</vt:lpstr>
      <vt:lpstr>Outline </vt:lpstr>
      <vt:lpstr>Introduction </vt:lpstr>
      <vt:lpstr>Therapeutic enzymes for cancer treatment</vt:lpstr>
      <vt:lpstr>L-asparaginase (EC 3.5.1.1)</vt:lpstr>
      <vt:lpstr>L-asparaginase sources </vt:lpstr>
      <vt:lpstr>L-Asparaginases used in the clinics</vt:lpstr>
      <vt:lpstr>Clinically important L-asparaginases</vt:lpstr>
      <vt:lpstr>Clinically … </vt:lpstr>
      <vt:lpstr>Clinically … </vt:lpstr>
      <vt:lpstr>Why exogenous sources of L-asparaginases </vt:lpstr>
      <vt:lpstr>Kinetic parameters of L-asparaginases in recent publications </vt:lpstr>
      <vt:lpstr>Bacterial type-II L-asparaginases</vt:lpstr>
      <vt:lpstr>L-asparaginases from Fungi</vt:lpstr>
      <vt:lpstr>Ongoing efforts</vt:lpstr>
      <vt:lpstr>1. Recombinant ASNase</vt:lpstr>
      <vt:lpstr>Recombinant … </vt:lpstr>
      <vt:lpstr>Comparison of L-ASNases from different sources based on Km values  </vt:lpstr>
      <vt:lpstr>2. Encapsulation</vt:lpstr>
      <vt:lpstr>3. Site-directed mutagenesis </vt:lpstr>
      <vt:lpstr>4. Structure-based rational design</vt:lpstr>
      <vt:lpstr>5. In silico screening</vt:lpstr>
      <vt:lpstr>In silico … </vt:lpstr>
      <vt:lpstr>6. Searching novel L-Asparaginases</vt:lpstr>
      <vt:lpstr>L-asparaginase related research in Ethiopia</vt:lpstr>
      <vt:lpstr>Cancer related research in Ethiopia</vt:lpstr>
      <vt:lpstr>Conclusion </vt:lpstr>
      <vt:lpstr>Acknowledgments </vt:lpstr>
      <vt:lpstr>PowerPoint Presentation</vt:lpstr>
      <vt:lpstr>History of L-asparaginase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T</dc:creator>
  <cp:lastModifiedBy>Microsoft account</cp:lastModifiedBy>
  <cp:revision>307</cp:revision>
  <dcterms:created xsi:type="dcterms:W3CDTF">2022-11-15T16:08:00Z</dcterms:created>
  <dcterms:modified xsi:type="dcterms:W3CDTF">2023-07-29T13:52:21Z</dcterms:modified>
</cp:coreProperties>
</file>